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0" r:id="rId2"/>
  </p:sldIdLst>
  <p:sldSz cx="7099300" cy="99425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92"/>
    <p:restoredTop sz="94701"/>
  </p:normalViewPr>
  <p:slideViewPr>
    <p:cSldViewPr snapToGrid="0">
      <p:cViewPr varScale="1">
        <p:scale>
          <a:sx n="83" d="100"/>
          <a:sy n="83" d="100"/>
        </p:scale>
        <p:origin x="3552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9BC07-D09E-824B-B552-05E2E99B71CC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7275" y="1143000"/>
            <a:ext cx="22034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B73340-D26C-414E-BE20-46968DC4CB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4831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2448" y="1627167"/>
            <a:ext cx="6034405" cy="3461467"/>
          </a:xfrm>
        </p:spPr>
        <p:txBody>
          <a:bodyPr anchor="b"/>
          <a:lstStyle>
            <a:lvl1pPr algn="ctr">
              <a:defRPr sz="4658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87413" y="5222121"/>
            <a:ext cx="5324475" cy="2400472"/>
          </a:xfrm>
        </p:spPr>
        <p:txBody>
          <a:bodyPr/>
          <a:lstStyle>
            <a:lvl1pPr marL="0" indent="0" algn="ctr">
              <a:buNone/>
              <a:defRPr sz="1863"/>
            </a:lvl1pPr>
            <a:lvl2pPr marL="354970" indent="0" algn="ctr">
              <a:buNone/>
              <a:defRPr sz="1553"/>
            </a:lvl2pPr>
            <a:lvl3pPr marL="709940" indent="0" algn="ctr">
              <a:buNone/>
              <a:defRPr sz="1398"/>
            </a:lvl3pPr>
            <a:lvl4pPr marL="1064910" indent="0" algn="ctr">
              <a:buNone/>
              <a:defRPr sz="1242"/>
            </a:lvl4pPr>
            <a:lvl5pPr marL="1419880" indent="0" algn="ctr">
              <a:buNone/>
              <a:defRPr sz="1242"/>
            </a:lvl5pPr>
            <a:lvl6pPr marL="1774850" indent="0" algn="ctr">
              <a:buNone/>
              <a:defRPr sz="1242"/>
            </a:lvl6pPr>
            <a:lvl7pPr marL="2129820" indent="0" algn="ctr">
              <a:buNone/>
              <a:defRPr sz="1242"/>
            </a:lvl7pPr>
            <a:lvl8pPr marL="2484791" indent="0" algn="ctr">
              <a:buNone/>
              <a:defRPr sz="1242"/>
            </a:lvl8pPr>
            <a:lvl9pPr marL="2839761" indent="0" algn="ctr">
              <a:buNone/>
              <a:defRPr sz="1242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5528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8209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080437" y="529347"/>
            <a:ext cx="1530787" cy="8425820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8077" y="529347"/>
            <a:ext cx="4503618" cy="8425820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2552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480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4380" y="2478726"/>
            <a:ext cx="6123146" cy="4135809"/>
          </a:xfrm>
        </p:spPr>
        <p:txBody>
          <a:bodyPr anchor="b"/>
          <a:lstStyle>
            <a:lvl1pPr>
              <a:defRPr sz="4658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4380" y="6653661"/>
            <a:ext cx="6123146" cy="2174924"/>
          </a:xfrm>
        </p:spPr>
        <p:txBody>
          <a:bodyPr/>
          <a:lstStyle>
            <a:lvl1pPr marL="0" indent="0">
              <a:buNone/>
              <a:defRPr sz="1863">
                <a:solidFill>
                  <a:schemeClr val="tx1">
                    <a:tint val="82000"/>
                  </a:schemeClr>
                </a:solidFill>
              </a:defRPr>
            </a:lvl1pPr>
            <a:lvl2pPr marL="354970" indent="0">
              <a:buNone/>
              <a:defRPr sz="1553">
                <a:solidFill>
                  <a:schemeClr val="tx1">
                    <a:tint val="82000"/>
                  </a:schemeClr>
                </a:solidFill>
              </a:defRPr>
            </a:lvl2pPr>
            <a:lvl3pPr marL="709940" indent="0">
              <a:buNone/>
              <a:defRPr sz="1398">
                <a:solidFill>
                  <a:schemeClr val="tx1">
                    <a:tint val="82000"/>
                  </a:schemeClr>
                </a:solidFill>
              </a:defRPr>
            </a:lvl3pPr>
            <a:lvl4pPr marL="1064910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4pPr>
            <a:lvl5pPr marL="1419880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5pPr>
            <a:lvl6pPr marL="1774850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6pPr>
            <a:lvl7pPr marL="2129820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7pPr>
            <a:lvl8pPr marL="2484791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8pPr>
            <a:lvl9pPr marL="2839761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631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88077" y="2646734"/>
            <a:ext cx="3017203" cy="630843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94020" y="2646734"/>
            <a:ext cx="3017203" cy="630843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441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002" y="529349"/>
            <a:ext cx="6123146" cy="1921760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9002" y="2437297"/>
            <a:ext cx="3003336" cy="1194482"/>
          </a:xfrm>
        </p:spPr>
        <p:txBody>
          <a:bodyPr anchor="b"/>
          <a:lstStyle>
            <a:lvl1pPr marL="0" indent="0">
              <a:buNone/>
              <a:defRPr sz="1863" b="1"/>
            </a:lvl1pPr>
            <a:lvl2pPr marL="354970" indent="0">
              <a:buNone/>
              <a:defRPr sz="1553" b="1"/>
            </a:lvl2pPr>
            <a:lvl3pPr marL="709940" indent="0">
              <a:buNone/>
              <a:defRPr sz="1398" b="1"/>
            </a:lvl3pPr>
            <a:lvl4pPr marL="1064910" indent="0">
              <a:buNone/>
              <a:defRPr sz="1242" b="1"/>
            </a:lvl4pPr>
            <a:lvl5pPr marL="1419880" indent="0">
              <a:buNone/>
              <a:defRPr sz="1242" b="1"/>
            </a:lvl5pPr>
            <a:lvl6pPr marL="1774850" indent="0">
              <a:buNone/>
              <a:defRPr sz="1242" b="1"/>
            </a:lvl6pPr>
            <a:lvl7pPr marL="2129820" indent="0">
              <a:buNone/>
              <a:defRPr sz="1242" b="1"/>
            </a:lvl7pPr>
            <a:lvl8pPr marL="2484791" indent="0">
              <a:buNone/>
              <a:defRPr sz="1242" b="1"/>
            </a:lvl8pPr>
            <a:lvl9pPr marL="2839761" indent="0">
              <a:buNone/>
              <a:defRPr sz="1242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9002" y="3631779"/>
            <a:ext cx="3003336" cy="534180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594021" y="2437297"/>
            <a:ext cx="3018127" cy="1194482"/>
          </a:xfrm>
        </p:spPr>
        <p:txBody>
          <a:bodyPr anchor="b"/>
          <a:lstStyle>
            <a:lvl1pPr marL="0" indent="0">
              <a:buNone/>
              <a:defRPr sz="1863" b="1"/>
            </a:lvl1pPr>
            <a:lvl2pPr marL="354970" indent="0">
              <a:buNone/>
              <a:defRPr sz="1553" b="1"/>
            </a:lvl2pPr>
            <a:lvl3pPr marL="709940" indent="0">
              <a:buNone/>
              <a:defRPr sz="1398" b="1"/>
            </a:lvl3pPr>
            <a:lvl4pPr marL="1064910" indent="0">
              <a:buNone/>
              <a:defRPr sz="1242" b="1"/>
            </a:lvl4pPr>
            <a:lvl5pPr marL="1419880" indent="0">
              <a:buNone/>
              <a:defRPr sz="1242" b="1"/>
            </a:lvl5pPr>
            <a:lvl6pPr marL="1774850" indent="0">
              <a:buNone/>
              <a:defRPr sz="1242" b="1"/>
            </a:lvl6pPr>
            <a:lvl7pPr marL="2129820" indent="0">
              <a:buNone/>
              <a:defRPr sz="1242" b="1"/>
            </a:lvl7pPr>
            <a:lvl8pPr marL="2484791" indent="0">
              <a:buNone/>
              <a:defRPr sz="1242" b="1"/>
            </a:lvl8pPr>
            <a:lvl9pPr marL="2839761" indent="0">
              <a:buNone/>
              <a:defRPr sz="1242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594021" y="3631779"/>
            <a:ext cx="3018127" cy="534180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82645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338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411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002" y="662834"/>
            <a:ext cx="2289709" cy="2319920"/>
          </a:xfrm>
        </p:spPr>
        <p:txBody>
          <a:bodyPr anchor="b"/>
          <a:lstStyle>
            <a:lvl1pPr>
              <a:defRPr sz="2484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18127" y="1431540"/>
            <a:ext cx="3594021" cy="7065628"/>
          </a:xfrm>
        </p:spPr>
        <p:txBody>
          <a:bodyPr/>
          <a:lstStyle>
            <a:lvl1pPr>
              <a:defRPr sz="2484"/>
            </a:lvl1pPr>
            <a:lvl2pPr>
              <a:defRPr sz="2174"/>
            </a:lvl2pPr>
            <a:lvl3pPr>
              <a:defRPr sz="1863"/>
            </a:lvl3pPr>
            <a:lvl4pPr>
              <a:defRPr sz="1553"/>
            </a:lvl4pPr>
            <a:lvl5pPr>
              <a:defRPr sz="1553"/>
            </a:lvl5pPr>
            <a:lvl6pPr>
              <a:defRPr sz="1553"/>
            </a:lvl6pPr>
            <a:lvl7pPr>
              <a:defRPr sz="1553"/>
            </a:lvl7pPr>
            <a:lvl8pPr>
              <a:defRPr sz="1553"/>
            </a:lvl8pPr>
            <a:lvl9pPr>
              <a:defRPr sz="1553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9002" y="2982754"/>
            <a:ext cx="2289709" cy="5525921"/>
          </a:xfrm>
        </p:spPr>
        <p:txBody>
          <a:bodyPr/>
          <a:lstStyle>
            <a:lvl1pPr marL="0" indent="0">
              <a:buNone/>
              <a:defRPr sz="1242"/>
            </a:lvl1pPr>
            <a:lvl2pPr marL="354970" indent="0">
              <a:buNone/>
              <a:defRPr sz="1087"/>
            </a:lvl2pPr>
            <a:lvl3pPr marL="709940" indent="0">
              <a:buNone/>
              <a:defRPr sz="932"/>
            </a:lvl3pPr>
            <a:lvl4pPr marL="1064910" indent="0">
              <a:buNone/>
              <a:defRPr sz="776"/>
            </a:lvl4pPr>
            <a:lvl5pPr marL="1419880" indent="0">
              <a:buNone/>
              <a:defRPr sz="776"/>
            </a:lvl5pPr>
            <a:lvl6pPr marL="1774850" indent="0">
              <a:buNone/>
              <a:defRPr sz="776"/>
            </a:lvl6pPr>
            <a:lvl7pPr marL="2129820" indent="0">
              <a:buNone/>
              <a:defRPr sz="776"/>
            </a:lvl7pPr>
            <a:lvl8pPr marL="2484791" indent="0">
              <a:buNone/>
              <a:defRPr sz="776"/>
            </a:lvl8pPr>
            <a:lvl9pPr marL="2839761" indent="0">
              <a:buNone/>
              <a:defRPr sz="776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4155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002" y="662834"/>
            <a:ext cx="2289709" cy="2319920"/>
          </a:xfrm>
        </p:spPr>
        <p:txBody>
          <a:bodyPr anchor="b"/>
          <a:lstStyle>
            <a:lvl1pPr>
              <a:defRPr sz="2484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18127" y="1431540"/>
            <a:ext cx="3594021" cy="7065628"/>
          </a:xfrm>
        </p:spPr>
        <p:txBody>
          <a:bodyPr anchor="t"/>
          <a:lstStyle>
            <a:lvl1pPr marL="0" indent="0">
              <a:buNone/>
              <a:defRPr sz="2484"/>
            </a:lvl1pPr>
            <a:lvl2pPr marL="354970" indent="0">
              <a:buNone/>
              <a:defRPr sz="2174"/>
            </a:lvl2pPr>
            <a:lvl3pPr marL="709940" indent="0">
              <a:buNone/>
              <a:defRPr sz="1863"/>
            </a:lvl3pPr>
            <a:lvl4pPr marL="1064910" indent="0">
              <a:buNone/>
              <a:defRPr sz="1553"/>
            </a:lvl4pPr>
            <a:lvl5pPr marL="1419880" indent="0">
              <a:buNone/>
              <a:defRPr sz="1553"/>
            </a:lvl5pPr>
            <a:lvl6pPr marL="1774850" indent="0">
              <a:buNone/>
              <a:defRPr sz="1553"/>
            </a:lvl6pPr>
            <a:lvl7pPr marL="2129820" indent="0">
              <a:buNone/>
              <a:defRPr sz="1553"/>
            </a:lvl7pPr>
            <a:lvl8pPr marL="2484791" indent="0">
              <a:buNone/>
              <a:defRPr sz="1553"/>
            </a:lvl8pPr>
            <a:lvl9pPr marL="2839761" indent="0">
              <a:buNone/>
              <a:defRPr sz="1553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9002" y="2982754"/>
            <a:ext cx="2289709" cy="5525921"/>
          </a:xfrm>
        </p:spPr>
        <p:txBody>
          <a:bodyPr/>
          <a:lstStyle>
            <a:lvl1pPr marL="0" indent="0">
              <a:buNone/>
              <a:defRPr sz="1242"/>
            </a:lvl1pPr>
            <a:lvl2pPr marL="354970" indent="0">
              <a:buNone/>
              <a:defRPr sz="1087"/>
            </a:lvl2pPr>
            <a:lvl3pPr marL="709940" indent="0">
              <a:buNone/>
              <a:defRPr sz="932"/>
            </a:lvl3pPr>
            <a:lvl4pPr marL="1064910" indent="0">
              <a:buNone/>
              <a:defRPr sz="776"/>
            </a:lvl4pPr>
            <a:lvl5pPr marL="1419880" indent="0">
              <a:buNone/>
              <a:defRPr sz="776"/>
            </a:lvl5pPr>
            <a:lvl6pPr marL="1774850" indent="0">
              <a:buNone/>
              <a:defRPr sz="776"/>
            </a:lvl6pPr>
            <a:lvl7pPr marL="2129820" indent="0">
              <a:buNone/>
              <a:defRPr sz="776"/>
            </a:lvl7pPr>
            <a:lvl8pPr marL="2484791" indent="0">
              <a:buNone/>
              <a:defRPr sz="776"/>
            </a:lvl8pPr>
            <a:lvl9pPr marL="2839761" indent="0">
              <a:buNone/>
              <a:defRPr sz="776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7737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88077" y="529349"/>
            <a:ext cx="6123146" cy="19217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8077" y="2646734"/>
            <a:ext cx="6123146" cy="630843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88077" y="9215239"/>
            <a:ext cx="1597343" cy="5293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3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51643" y="9215239"/>
            <a:ext cx="2396014" cy="5293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3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13880" y="9215239"/>
            <a:ext cx="1597343" cy="5293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3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390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09940" rtl="0" eaLnBrk="1" latinLnBrk="0" hangingPunct="1">
        <a:lnSpc>
          <a:spcPct val="90000"/>
        </a:lnSpc>
        <a:spcBef>
          <a:spcPct val="0"/>
        </a:spcBef>
        <a:buNone/>
        <a:defRPr sz="341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7485" indent="-177485" algn="l" defTabSz="709940" rtl="0" eaLnBrk="1" latinLnBrk="0" hangingPunct="1">
        <a:lnSpc>
          <a:spcPct val="90000"/>
        </a:lnSpc>
        <a:spcBef>
          <a:spcPts val="776"/>
        </a:spcBef>
        <a:buFont typeface="Arial" panose="020B0604020202020204" pitchFamily="34" charset="0"/>
        <a:buChar char="•"/>
        <a:defRPr sz="2174" kern="1200">
          <a:solidFill>
            <a:schemeClr val="tx1"/>
          </a:solidFill>
          <a:latin typeface="+mn-lt"/>
          <a:ea typeface="+mn-ea"/>
          <a:cs typeface="+mn-cs"/>
        </a:defRPr>
      </a:lvl1pPr>
      <a:lvl2pPr marL="53245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863" kern="1200">
          <a:solidFill>
            <a:schemeClr val="tx1"/>
          </a:solidFill>
          <a:latin typeface="+mn-lt"/>
          <a:ea typeface="+mn-ea"/>
          <a:cs typeface="+mn-cs"/>
        </a:defRPr>
      </a:lvl2pPr>
      <a:lvl3pPr marL="88742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553" kern="1200">
          <a:solidFill>
            <a:schemeClr val="tx1"/>
          </a:solidFill>
          <a:latin typeface="+mn-lt"/>
          <a:ea typeface="+mn-ea"/>
          <a:cs typeface="+mn-cs"/>
        </a:defRPr>
      </a:lvl3pPr>
      <a:lvl4pPr marL="124239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4pPr>
      <a:lvl5pPr marL="159736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5pPr>
      <a:lvl6pPr marL="195233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6pPr>
      <a:lvl7pPr marL="2307306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7pPr>
      <a:lvl8pPr marL="2662276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8pPr>
      <a:lvl9pPr marL="3017246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1pPr>
      <a:lvl2pPr marL="35497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2pPr>
      <a:lvl3pPr marL="70994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3pPr>
      <a:lvl4pPr marL="106491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4pPr>
      <a:lvl5pPr marL="141988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5pPr>
      <a:lvl6pPr marL="177485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6pPr>
      <a:lvl7pPr marL="212982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7pPr>
      <a:lvl8pPr marL="2484791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8pPr>
      <a:lvl9pPr marL="2839761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Group 44">
            <a:extLst>
              <a:ext uri="{FF2B5EF4-FFF2-40B4-BE49-F238E27FC236}">
                <a16:creationId xmlns:a16="http://schemas.microsoft.com/office/drawing/2014/main" id="{69DFFE7B-AC7B-041B-5AF3-AF7FDA784319}"/>
              </a:ext>
            </a:extLst>
          </p:cNvPr>
          <p:cNvGrpSpPr/>
          <p:nvPr/>
        </p:nvGrpSpPr>
        <p:grpSpPr>
          <a:xfrm>
            <a:off x="1278572" y="2589371"/>
            <a:ext cx="4542156" cy="4763767"/>
            <a:chOff x="0" y="0"/>
            <a:chExt cx="4542492" cy="4763956"/>
          </a:xfrm>
        </p:grpSpPr>
        <p:sp>
          <p:nvSpPr>
            <p:cNvPr id="46" name="Flowchart: Card 5">
              <a:extLst>
                <a:ext uri="{FF2B5EF4-FFF2-40B4-BE49-F238E27FC236}">
                  <a16:creationId xmlns:a16="http://schemas.microsoft.com/office/drawing/2014/main" id="{21174CAD-0C4F-48D7-8FC5-D6997E51D6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0" y="0"/>
              <a:ext cx="1960562" cy="550863"/>
            </a:xfrm>
            <a:prstGeom prst="flowChartPunchedCard">
              <a:avLst/>
            </a:prstGeom>
            <a:solidFill>
              <a:srgbClr val="FFFFFF"/>
            </a:solidFill>
            <a:ln w="12700">
              <a:solidFill>
                <a:srgbClr val="70AD47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algn="ctr" eaLnBrk="0" fontAlgn="base" hangingPunct="0"/>
              <a:r>
                <a:rPr lang="en-US" sz="12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Total CRCs</a:t>
              </a:r>
              <a:endParaRPr lang="en-GB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 eaLnBrk="0" fontAlgn="base" hangingPunct="0"/>
              <a:r>
                <a:rPr lang="en-US" sz="12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6605</a:t>
              </a:r>
              <a:endParaRPr lang="en-GB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Flowchart: Card 4">
              <a:extLst>
                <a:ext uri="{FF2B5EF4-FFF2-40B4-BE49-F238E27FC236}">
                  <a16:creationId xmlns:a16="http://schemas.microsoft.com/office/drawing/2014/main" id="{38E21150-A04C-49B7-801D-710C412AF8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2142" y="0"/>
              <a:ext cx="1530350" cy="550862"/>
            </a:xfrm>
            <a:prstGeom prst="flowChartPunchedCard">
              <a:avLst/>
            </a:prstGeom>
            <a:solidFill>
              <a:srgbClr val="FFFFFF"/>
            </a:solidFill>
            <a:ln w="12700">
              <a:solidFill>
                <a:srgbClr val="70AD47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algn="ctr" eaLnBrk="0" fontAlgn="base" hangingPunct="0"/>
              <a:r>
                <a:rPr lang="en-US" sz="12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No atypical KRAS</a:t>
              </a:r>
              <a:endParaRPr lang="en-GB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 eaLnBrk="0" fontAlgn="base" hangingPunct="0"/>
              <a:r>
                <a:rPr lang="en-US" sz="12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6270</a:t>
              </a:r>
              <a:endParaRPr lang="en-GB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Flowchart: Card 7">
              <a:extLst>
                <a:ext uri="{FF2B5EF4-FFF2-40B4-BE49-F238E27FC236}">
                  <a16:creationId xmlns:a16="http://schemas.microsoft.com/office/drawing/2014/main" id="{A5E963F3-7604-4C0B-8061-0D7B9F1C01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0" y="977153"/>
              <a:ext cx="1960562" cy="550862"/>
            </a:xfrm>
            <a:prstGeom prst="flowChartPunchedCard">
              <a:avLst/>
            </a:prstGeom>
            <a:solidFill>
              <a:srgbClr val="FFFFFF"/>
            </a:solidFill>
            <a:ln w="12700">
              <a:solidFill>
                <a:srgbClr val="70AD47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algn="ctr" eaLnBrk="0" fontAlgn="base" hangingPunct="0"/>
              <a:r>
                <a:rPr lang="en-US" sz="12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typical KRAS</a:t>
              </a:r>
              <a:endParaRPr lang="en-GB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 eaLnBrk="0" fontAlgn="base" hangingPunct="0"/>
              <a:r>
                <a:rPr lang="en-US" sz="12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335</a:t>
              </a:r>
              <a:endParaRPr lang="en-GB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Flowchart: Card 6">
              <a:extLst>
                <a:ext uri="{FF2B5EF4-FFF2-40B4-BE49-F238E27FC236}">
                  <a16:creationId xmlns:a16="http://schemas.microsoft.com/office/drawing/2014/main" id="{090D9728-999E-4A65-9C37-B880BE6792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2142" y="977153"/>
              <a:ext cx="1530350" cy="550863"/>
            </a:xfrm>
            <a:prstGeom prst="flowChartPunchedCard">
              <a:avLst/>
            </a:prstGeom>
            <a:solidFill>
              <a:srgbClr val="FFFFFF"/>
            </a:solidFill>
            <a:ln w="12700">
              <a:solidFill>
                <a:srgbClr val="70AD47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algn="ctr" eaLnBrk="0" fontAlgn="base" hangingPunct="0"/>
              <a:r>
                <a:rPr lang="en-US" sz="12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athogenic BRAF</a:t>
              </a:r>
              <a:endParaRPr lang="en-GB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 eaLnBrk="0" fontAlgn="base" hangingPunct="0"/>
              <a:r>
                <a:rPr lang="en-US" sz="12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18</a:t>
              </a:r>
              <a:endParaRPr lang="en-GB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Flowchart: Card 9">
              <a:extLst>
                <a:ext uri="{FF2B5EF4-FFF2-40B4-BE49-F238E27FC236}">
                  <a16:creationId xmlns:a16="http://schemas.microsoft.com/office/drawing/2014/main" id="{55BC9CE3-8288-47B6-8E84-C168C47A3F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0" y="1963270"/>
              <a:ext cx="1960562" cy="550863"/>
            </a:xfrm>
            <a:prstGeom prst="flowChartPunchedCard">
              <a:avLst/>
            </a:prstGeom>
            <a:solidFill>
              <a:srgbClr val="FFFFFF"/>
            </a:solidFill>
            <a:ln w="12700">
              <a:solidFill>
                <a:srgbClr val="70AD47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algn="ctr" eaLnBrk="0" fontAlgn="base" hangingPunct="0"/>
              <a:r>
                <a:rPr lang="en-US" sz="12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typical KRAS, no BRAF </a:t>
              </a:r>
              <a:endParaRPr lang="en-GB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 eaLnBrk="0" fontAlgn="base" hangingPunct="0"/>
              <a:r>
                <a:rPr lang="en-US" sz="12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317</a:t>
              </a:r>
              <a:endParaRPr lang="en-GB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Flowchart: Card 8">
              <a:extLst>
                <a:ext uri="{FF2B5EF4-FFF2-40B4-BE49-F238E27FC236}">
                  <a16:creationId xmlns:a16="http://schemas.microsoft.com/office/drawing/2014/main" id="{92AEDE7D-5DCE-4702-BA9B-D2F141D9C1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2142" y="1963270"/>
              <a:ext cx="1530350" cy="550863"/>
            </a:xfrm>
            <a:prstGeom prst="flowChartPunchedCard">
              <a:avLst/>
            </a:prstGeom>
            <a:solidFill>
              <a:srgbClr val="FFFFFF"/>
            </a:solidFill>
            <a:ln w="12700">
              <a:solidFill>
                <a:srgbClr val="70AD47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algn="ctr" eaLnBrk="0" fontAlgn="base" hangingPunct="0"/>
              <a:r>
                <a:rPr lang="en-US" sz="12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Typical KRAS</a:t>
              </a:r>
              <a:endParaRPr lang="en-GB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 eaLnBrk="0" fontAlgn="base" hangingPunct="0"/>
              <a:r>
                <a:rPr lang="en-US" sz="12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13</a:t>
              </a:r>
              <a:endParaRPr lang="en-GB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Flowchart: Card 11">
              <a:extLst>
                <a:ext uri="{FF2B5EF4-FFF2-40B4-BE49-F238E27FC236}">
                  <a16:creationId xmlns:a16="http://schemas.microsoft.com/office/drawing/2014/main" id="{D0E6AD03-F94D-40F4-96ED-A8E7068843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0" y="2940423"/>
              <a:ext cx="1960245" cy="836579"/>
            </a:xfrm>
            <a:prstGeom prst="flowChartPunchedCard">
              <a:avLst/>
            </a:prstGeom>
            <a:solidFill>
              <a:srgbClr val="FFFFFF"/>
            </a:solidFill>
            <a:ln w="12700">
              <a:solidFill>
                <a:srgbClr val="70AD47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noAutofit/>
            </a:bodyPr>
            <a:lstStyle/>
            <a:p>
              <a:pPr algn="ctr" eaLnBrk="0" fontAlgn="base" hangingPunct="0"/>
              <a:r>
                <a:rPr lang="en-US" sz="12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typical KRAS, no BRAF or typical KRAS</a:t>
              </a:r>
              <a:endParaRPr lang="en-GB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 eaLnBrk="0" fontAlgn="base" hangingPunct="0"/>
              <a:r>
                <a:rPr lang="en-US" sz="12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304</a:t>
              </a:r>
              <a:endParaRPr lang="en-GB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Flowchart: Card 10">
              <a:extLst>
                <a:ext uri="{FF2B5EF4-FFF2-40B4-BE49-F238E27FC236}">
                  <a16:creationId xmlns:a16="http://schemas.microsoft.com/office/drawing/2014/main" id="{8929A73D-D6BB-4072-AF05-469B16D42D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2142" y="2940423"/>
              <a:ext cx="1530350" cy="836295"/>
            </a:xfrm>
            <a:prstGeom prst="flowChartPunchedCard">
              <a:avLst/>
            </a:prstGeom>
            <a:solidFill>
              <a:srgbClr val="FFFFFF"/>
            </a:solidFill>
            <a:ln w="12700">
              <a:solidFill>
                <a:srgbClr val="70AD47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noAutofit/>
            </a:bodyPr>
            <a:lstStyle/>
            <a:p>
              <a:pPr algn="ctr" eaLnBrk="0" fontAlgn="base" hangingPunct="0"/>
              <a:r>
                <a:rPr lang="en-US" sz="12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Other Ras (NRAS, NF1) </a:t>
              </a:r>
              <a:endParaRPr lang="en-GB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 eaLnBrk="0" fontAlgn="base" hangingPunct="0"/>
              <a:r>
                <a:rPr lang="en-US" sz="12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13</a:t>
              </a:r>
              <a:endParaRPr lang="en-GB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Flowchart: Card 13">
              <a:extLst>
                <a:ext uri="{FF2B5EF4-FFF2-40B4-BE49-F238E27FC236}">
                  <a16:creationId xmlns:a16="http://schemas.microsoft.com/office/drawing/2014/main" id="{61935428-39DF-45DA-87FA-2D9159019F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0" y="4213411"/>
              <a:ext cx="1960245" cy="550545"/>
            </a:xfrm>
            <a:prstGeom prst="flowChartPunchedCard">
              <a:avLst/>
            </a:prstGeom>
            <a:solidFill>
              <a:srgbClr val="FFFFFF"/>
            </a:solidFill>
            <a:ln w="12700">
              <a:solidFill>
                <a:srgbClr val="70AD47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algn="ctr" eaLnBrk="0" fontAlgn="base" hangingPunct="0"/>
              <a:r>
                <a:rPr lang="en-US" sz="12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typical KRAS alone</a:t>
              </a:r>
              <a:endParaRPr lang="en-GB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 eaLnBrk="0" fontAlgn="base" hangingPunct="0"/>
              <a:r>
                <a:rPr lang="en-US" sz="12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291</a:t>
              </a:r>
              <a:endParaRPr lang="en-GB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5" name="Straight Arrow Connector 54">
              <a:extLst>
                <a:ext uri="{FF2B5EF4-FFF2-40B4-BE49-F238E27FC236}">
                  <a16:creationId xmlns:a16="http://schemas.microsoft.com/office/drawing/2014/main" id="{26B66022-C86E-4AE6-90E7-5ECC53FEE08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63271" y="354106"/>
              <a:ext cx="1049338" cy="1"/>
            </a:xfrm>
            <a:prstGeom prst="straightConnector1">
              <a:avLst/>
            </a:prstGeom>
            <a:ln w="19050">
              <a:solidFill>
                <a:srgbClr val="70AD47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id="{B7AB93E2-81DE-448C-BF67-44EB9A783BB5}"/>
                </a:ext>
              </a:extLst>
            </p:cNvPr>
            <p:cNvCxnSpPr>
              <a:cxnSpLocks/>
            </p:cNvCxnSpPr>
            <p:nvPr/>
          </p:nvCxnSpPr>
          <p:spPr>
            <a:xfrm>
              <a:off x="1963271" y="1331258"/>
              <a:ext cx="1049338" cy="1"/>
            </a:xfrm>
            <a:prstGeom prst="straightConnector1">
              <a:avLst/>
            </a:prstGeom>
            <a:ln w="19050">
              <a:solidFill>
                <a:srgbClr val="70AD47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Arrow Connector 56">
              <a:extLst>
                <a:ext uri="{FF2B5EF4-FFF2-40B4-BE49-F238E27FC236}">
                  <a16:creationId xmlns:a16="http://schemas.microsoft.com/office/drawing/2014/main" id="{1C190682-147D-4EE5-9066-96D65D88F238}"/>
                </a:ext>
              </a:extLst>
            </p:cNvPr>
            <p:cNvCxnSpPr>
              <a:cxnSpLocks/>
            </p:cNvCxnSpPr>
            <p:nvPr/>
          </p:nvCxnSpPr>
          <p:spPr>
            <a:xfrm>
              <a:off x="1963271" y="2308411"/>
              <a:ext cx="1049338" cy="0"/>
            </a:xfrm>
            <a:prstGeom prst="straightConnector1">
              <a:avLst/>
            </a:prstGeom>
            <a:ln w="19050">
              <a:solidFill>
                <a:srgbClr val="70AD47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Arrow Connector 57">
              <a:extLst>
                <a:ext uri="{FF2B5EF4-FFF2-40B4-BE49-F238E27FC236}">
                  <a16:creationId xmlns:a16="http://schemas.microsoft.com/office/drawing/2014/main" id="{65ACAAD3-3876-48F4-8A74-4E07716372E2}"/>
                </a:ext>
              </a:extLst>
            </p:cNvPr>
            <p:cNvCxnSpPr>
              <a:cxnSpLocks/>
            </p:cNvCxnSpPr>
            <p:nvPr/>
          </p:nvCxnSpPr>
          <p:spPr>
            <a:xfrm>
              <a:off x="1963271" y="3294529"/>
              <a:ext cx="1049338" cy="0"/>
            </a:xfrm>
            <a:prstGeom prst="straightConnector1">
              <a:avLst/>
            </a:prstGeom>
            <a:ln w="19050">
              <a:solidFill>
                <a:srgbClr val="70AD47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Arrow Connector 58">
              <a:extLst>
                <a:ext uri="{FF2B5EF4-FFF2-40B4-BE49-F238E27FC236}">
                  <a16:creationId xmlns:a16="http://schemas.microsoft.com/office/drawing/2014/main" id="{6FBCD184-B4DD-4F38-94C6-30E1759628DB}"/>
                </a:ext>
              </a:extLst>
            </p:cNvPr>
            <p:cNvCxnSpPr>
              <a:cxnSpLocks/>
            </p:cNvCxnSpPr>
            <p:nvPr/>
          </p:nvCxnSpPr>
          <p:spPr>
            <a:xfrm>
              <a:off x="981636" y="1532964"/>
              <a:ext cx="0" cy="427038"/>
            </a:xfrm>
            <a:prstGeom prst="straightConnector1">
              <a:avLst/>
            </a:prstGeom>
            <a:ln w="19050">
              <a:solidFill>
                <a:srgbClr val="70AD47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Arrow Connector 59">
              <a:extLst>
                <a:ext uri="{FF2B5EF4-FFF2-40B4-BE49-F238E27FC236}">
                  <a16:creationId xmlns:a16="http://schemas.microsoft.com/office/drawing/2014/main" id="{5A19365A-BC43-497B-9602-8F471FF59BC9}"/>
                </a:ext>
              </a:extLst>
            </p:cNvPr>
            <p:cNvCxnSpPr>
              <a:cxnSpLocks/>
            </p:cNvCxnSpPr>
            <p:nvPr/>
          </p:nvCxnSpPr>
          <p:spPr>
            <a:xfrm>
              <a:off x="986865" y="3792070"/>
              <a:ext cx="0" cy="428625"/>
            </a:xfrm>
            <a:prstGeom prst="straightConnector1">
              <a:avLst/>
            </a:prstGeom>
            <a:ln w="19050">
              <a:solidFill>
                <a:srgbClr val="70AD47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2" name="TextBox 61">
            <a:extLst>
              <a:ext uri="{FF2B5EF4-FFF2-40B4-BE49-F238E27FC236}">
                <a16:creationId xmlns:a16="http://schemas.microsoft.com/office/drawing/2014/main" id="{CBC9F6A2-EBCF-1E04-900B-62572BF0306F}"/>
              </a:ext>
            </a:extLst>
          </p:cNvPr>
          <p:cNvSpPr txBox="1"/>
          <p:nvPr/>
        </p:nvSpPr>
        <p:spPr>
          <a:xfrm>
            <a:off x="493395" y="115539"/>
            <a:ext cx="6112510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u="sng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5. Atypical </a:t>
            </a:r>
            <a:r>
              <a:rPr lang="en-GB" sz="1400" b="1" i="1" u="sng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RAS</a:t>
            </a:r>
            <a:r>
              <a:rPr lang="en-GB" sz="1400" b="1" u="sng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utations and additional Ras pathway mutations.</a:t>
            </a:r>
            <a:r>
              <a:rPr lang="en-GB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 CONSORT-style diagram shows the breakdown of tumours with atypical </a:t>
            </a:r>
            <a:r>
              <a:rPr lang="en-GB" sz="14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RAS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utations by accompanying mutations in </a:t>
            </a:r>
            <a:r>
              <a:rPr lang="en-GB" sz="14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RAS, BRAF, NRAS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r </a:t>
            </a:r>
            <a:r>
              <a:rPr lang="en-GB" sz="14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F1.</a:t>
            </a:r>
            <a:endParaRPr lang="en-GB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06449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supplementary_figure_1" id="{7C626575-2EA4-F944-A432-58960AD0DE46}" vid="{83430D31-096D-FF42-AA65-42DAA4213C38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80</Words>
  <Application>Microsoft Macintosh PowerPoint</Application>
  <PresentationFormat>Custom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onnor Woolley</dc:creator>
  <cp:lastModifiedBy>Connor Woolley</cp:lastModifiedBy>
  <cp:revision>4</cp:revision>
  <dcterms:created xsi:type="dcterms:W3CDTF">2024-11-13T18:28:31Z</dcterms:created>
  <dcterms:modified xsi:type="dcterms:W3CDTF">2024-11-13T18:29:52Z</dcterms:modified>
</cp:coreProperties>
</file>